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ADAE60-8983-4145-82DC-03B4B7CFFC9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14444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ig X: shows DNA level conservation with rice and sorghum across introns accept where 3,214-bp TE (retro) is inserted.  Tblastn alignment with rice and sorghum proteins validates coding sequence, while exon/intron mapping confirmed structure of ge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FB17C-41D5-472A-8E71-495CDE1B0B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0DDB1-5274-4B1C-AF59-44D01F1CFB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80973-81C6-412D-A169-732D090FC9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5C773-25B7-4B65-9313-0C374F6F8D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A145B-BEC8-45B2-9A26-10EC137B37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099DD-53E9-41E3-A4F6-E0C5CC7DDF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1BCCE-BE5F-4152-8BCD-05E99D3498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8DC8C-D298-4AF2-A902-61A5B91139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E91A4-51A5-4E58-B205-92A4938471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59325-6E48-4F63-ACE8-7819E369F9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31A24-BEB5-4AA0-87CC-33538987D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7310E-FE26-4908-9534-9E2C78E978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4ED796-DEE7-4999-AC1B-C676E60BF3C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4401360" y="893880"/>
            <a:ext cx="21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266760" y="1327320"/>
            <a:ext cx="8534520" cy="34938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252000" y="598320"/>
            <a:ext cx="64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9. Example of recent insertions of LTR retrotransposon into the intron of an active gen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5T05:23:06Z</dcterms:created>
  <dc:creator>fushengw</dc:creator>
  <dc:description/>
  <dc:language>en-US</dc:language>
  <cp:lastModifiedBy>fushengw</cp:lastModifiedBy>
  <dcterms:modified xsi:type="dcterms:W3CDTF">2009-10-15T05:23:13Z</dcterms:modified>
  <cp:revision>1</cp:revision>
  <dc:subject/>
  <dc:title>Slide 1</dc:title>
</cp:coreProperties>
</file>